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1" r:id="rId3"/>
    <p:sldId id="262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509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506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240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5796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816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054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149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529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9406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613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272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518AF-7F3E-421F-BAB9-ECF50CD449F8}" type="datetimeFigureOut">
              <a:rPr lang="en-US" smtClean="0"/>
              <a:t>30-Sep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99779-1FAA-4B0E-AE60-E455B160B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810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01769" y="188667"/>
            <a:ext cx="11608157" cy="5669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1: Bacterial Strains, Growth Media and Exponential and Stationary Phase Time Points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3356" y="1847800"/>
            <a:ext cx="7745288" cy="316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57062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46"/>
          <p:cNvSpPr/>
          <p:nvPr/>
        </p:nvSpPr>
        <p:spPr>
          <a:xfrm>
            <a:off x="8608461" y="574880"/>
            <a:ext cx="3330497" cy="24172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3179238" y="5143959"/>
            <a:ext cx="2588105" cy="24174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/>
          <p:cNvSpPr/>
          <p:nvPr/>
        </p:nvSpPr>
        <p:spPr>
          <a:xfrm>
            <a:off x="3179238" y="3236512"/>
            <a:ext cx="2588105" cy="24174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3202072" y="1878894"/>
            <a:ext cx="2588105" cy="24174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3186962" y="574880"/>
            <a:ext cx="2588105" cy="24174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5958919" y="574880"/>
            <a:ext cx="2546576" cy="24159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/>
          <p:cNvSpPr/>
          <p:nvPr/>
        </p:nvSpPr>
        <p:spPr>
          <a:xfrm>
            <a:off x="5901966" y="3631638"/>
            <a:ext cx="2546576" cy="24159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5901966" y="1878894"/>
            <a:ext cx="2546576" cy="24159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/>
          <p:cNvSpPr/>
          <p:nvPr/>
        </p:nvSpPr>
        <p:spPr>
          <a:xfrm>
            <a:off x="103274" y="5139478"/>
            <a:ext cx="2804019" cy="24172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/>
          <p:cNvSpPr/>
          <p:nvPr/>
        </p:nvSpPr>
        <p:spPr>
          <a:xfrm>
            <a:off x="135906" y="2726367"/>
            <a:ext cx="2804019" cy="24172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/>
          <p:cNvSpPr/>
          <p:nvPr/>
        </p:nvSpPr>
        <p:spPr>
          <a:xfrm>
            <a:off x="104386" y="574880"/>
            <a:ext cx="2804019" cy="24172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48617" y="920469"/>
          <a:ext cx="2750903" cy="123482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03869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1220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</a:t>
                      </a:r>
                      <a:r>
                        <a:rPr lang="en-US" sz="11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O</a:t>
                      </a:r>
                      <a:r>
                        <a:rPr lang="en-US" sz="11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* 3 H</a:t>
                      </a:r>
                      <a:r>
                        <a:rPr lang="en-US" sz="11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H</a:t>
                      </a:r>
                      <a:r>
                        <a:rPr lang="en-US" sz="11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</a:t>
                      </a:r>
                      <a:r>
                        <a:rPr lang="en-US" sz="11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tassium Phosphat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 Acetat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monium Citrate Tribasi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 Ascorbic Acid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 Chlorid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139476" y="3055820"/>
          <a:ext cx="2761814" cy="144399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0673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44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amin hydrochloride (Thiamine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-aminobenzoic acid (4°C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-</a:t>
                      </a: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thothenic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cid </a:t>
                      </a: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icalcium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alt (4°C)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acin (Nicotinic acid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ridoxine hydrochlorid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137755" y="5484397"/>
          <a:ext cx="2772825" cy="89839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02473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480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tin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 % Ethano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w drops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0.01 M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m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3203735" y="920467"/>
          <a:ext cx="2586442" cy="59836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6404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4601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94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94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flavin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945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tic Acid 0.02 M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m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/>
        </p:nvGraphicFramePr>
        <p:xfrm>
          <a:off x="3203735" y="2220554"/>
          <a:ext cx="2586442" cy="52920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62655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5989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ic Acid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OH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0.01 M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 m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3203735" y="3590103"/>
          <a:ext cx="2539114" cy="1074801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70862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048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ine sulfat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anine hydrochlorid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idine 5’-monohosphate (4°C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l, 1 M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m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/>
        </p:nvGraphicFramePr>
        <p:xfrm>
          <a:off x="3203735" y="5484397"/>
          <a:ext cx="2547437" cy="52920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7169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3048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5910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aci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OH, 1 M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m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/>
        </p:nvGraphicFramePr>
        <p:xfrm>
          <a:off x="6000746" y="920469"/>
          <a:ext cx="2504749" cy="52920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3411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636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ymid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ter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 m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/>
        </p:nvGraphicFramePr>
        <p:xfrm>
          <a:off x="5920188" y="2220554"/>
          <a:ext cx="2523754" cy="70561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581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656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SO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x 7 H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2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SO</a:t>
                      </a:r>
                      <a:r>
                        <a:rPr lang="en-US" sz="11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x  H</a:t>
                      </a:r>
                      <a:r>
                        <a:rPr lang="en-US" sz="1100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3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SO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x 7 H</a:t>
                      </a:r>
                      <a:r>
                        <a:rPr lang="en-US" sz="1100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0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/>
        </p:nvGraphicFramePr>
        <p:xfrm>
          <a:off x="5912268" y="3954483"/>
          <a:ext cx="2531674" cy="52920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19338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3829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cos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ter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 ml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4" name="Table 13"/>
          <p:cNvGraphicFramePr>
            <a:graphicFrameLocks noGrp="1"/>
          </p:cNvGraphicFramePr>
          <p:nvPr/>
        </p:nvGraphicFramePr>
        <p:xfrm>
          <a:off x="8621281" y="920469"/>
          <a:ext cx="3317678" cy="3720846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1444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731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</a:t>
                      </a:r>
                      <a:endParaRPr lang="en-US" sz="110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 Alan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Argin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5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Asparagine monohydrat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Aspartic Acid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2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Cysteine hydrochloride monohydrat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Glutamic Acid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ine 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Histid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Isoleuc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Leuc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Lysine </a:t>
                      </a: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hydrochlorid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Methion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Phenylalan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Prol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Ser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Threon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Tryptophan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Tyros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 g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Valine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5 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  <p:sp>
        <p:nvSpPr>
          <p:cNvPr id="16" name="Rectangle 15"/>
          <p:cNvSpPr/>
          <p:nvPr/>
        </p:nvSpPr>
        <p:spPr>
          <a:xfrm>
            <a:off x="942686" y="574879"/>
            <a:ext cx="12186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al Medium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65098" y="2262397"/>
            <a:ext cx="2874827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solve in 100 ml of </a:t>
            </a:r>
            <a:r>
              <a:rPr kumimoji="0" lang="en-US" altLang="en-US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iQ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ter.  Add 100 ml to final solution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859694" y="2707481"/>
            <a:ext cx="14434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itamin Solution 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61999" y="4610775"/>
            <a:ext cx="291676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solve in 25 ml </a:t>
            </a:r>
            <a:r>
              <a:rPr kumimoji="0" lang="en-US" altLang="en-US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iQ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ter. Add 0.5 ml to the basal medium. 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874427" y="5121842"/>
            <a:ext cx="20313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iotin Solution	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43323" y="6451224"/>
            <a:ext cx="293544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 0.5 ml to the autoclaved basal medium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3741149" y="566425"/>
            <a:ext cx="16433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iboflavin Solution</a:t>
            </a:r>
            <a:endParaRPr lang="en-US" sz="1200" dirty="0"/>
          </a:p>
        </p:txBody>
      </p:sp>
      <p:sp>
        <p:nvSpPr>
          <p:cNvPr id="23" name="Rectangle 22"/>
          <p:cNvSpPr/>
          <p:nvPr/>
        </p:nvSpPr>
        <p:spPr>
          <a:xfrm>
            <a:off x="3137528" y="1504558"/>
            <a:ext cx="192873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 5 ml to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al </a:t>
            </a: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dium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3741149" y="1857974"/>
            <a:ext cx="16296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lic Acid Solution</a:t>
            </a:r>
            <a:endParaRPr lang="en-US" sz="1200" dirty="0"/>
          </a:p>
        </p:txBody>
      </p:sp>
      <p:sp>
        <p:nvSpPr>
          <p:cNvPr id="25" name="Rectangle 24"/>
          <p:cNvSpPr/>
          <p:nvPr/>
        </p:nvSpPr>
        <p:spPr>
          <a:xfrm>
            <a:off x="3135055" y="2814321"/>
            <a:ext cx="208422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 0.5 ml to basal medium.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3588311" y="3233288"/>
            <a:ext cx="18156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ucleic Acid Solution</a:t>
            </a:r>
            <a:endParaRPr lang="en-US" sz="1200" dirty="0"/>
          </a:p>
        </p:txBody>
      </p:sp>
      <p:sp>
        <p:nvSpPr>
          <p:cNvPr id="29" name="Rectangle 28"/>
          <p:cNvSpPr/>
          <p:nvPr/>
        </p:nvSpPr>
        <p:spPr>
          <a:xfrm>
            <a:off x="3148982" y="4756748"/>
            <a:ext cx="179568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 3 ml to basal media</a:t>
            </a:r>
            <a:endParaRPr lang="en-US" sz="1100" b="1" dirty="0"/>
          </a:p>
        </p:txBody>
      </p:sp>
      <p:sp>
        <p:nvSpPr>
          <p:cNvPr id="30" name="Rectangle 29"/>
          <p:cNvSpPr/>
          <p:nvPr/>
        </p:nvSpPr>
        <p:spPr>
          <a:xfrm>
            <a:off x="3833922" y="5137501"/>
            <a:ext cx="12731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racil Solution</a:t>
            </a:r>
            <a:endParaRPr lang="en-US" sz="1200" dirty="0"/>
          </a:p>
        </p:txBody>
      </p:sp>
      <p:sp>
        <p:nvSpPr>
          <p:cNvPr id="31" name="Rectangle 30"/>
          <p:cNvSpPr/>
          <p:nvPr/>
        </p:nvSpPr>
        <p:spPr>
          <a:xfrm>
            <a:off x="3135055" y="6074683"/>
            <a:ext cx="183415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 1 ml to basal media.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6455482" y="557175"/>
            <a:ext cx="166904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ymidine Solution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5926693" y="1504558"/>
            <a:ext cx="1834156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 1 ml to basal media.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6667178" y="1861189"/>
            <a:ext cx="20313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alt Solution	</a:t>
            </a:r>
            <a:endParaRPr lang="en-US" sz="1200" dirty="0"/>
          </a:p>
        </p:txBody>
      </p:sp>
      <p:sp>
        <p:nvSpPr>
          <p:cNvPr id="35" name="Rectangle 34"/>
          <p:cNvSpPr/>
          <p:nvPr/>
        </p:nvSpPr>
        <p:spPr>
          <a:xfrm>
            <a:off x="5843275" y="3003382"/>
            <a:ext cx="2626459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solve in </a:t>
            </a:r>
            <a:r>
              <a:rPr kumimoji="0" lang="en-US" altLang="en-US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Q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ter up to 10 ml. Add 1 ml to the autoclaved basal media. </a:t>
            </a:r>
            <a:endParaRPr lang="en-US" sz="1100" b="1" dirty="0"/>
          </a:p>
        </p:txBody>
      </p:sp>
      <p:sp>
        <p:nvSpPr>
          <p:cNvPr id="36" name="Rectangle 35"/>
          <p:cNvSpPr/>
          <p:nvPr/>
        </p:nvSpPr>
        <p:spPr>
          <a:xfrm>
            <a:off x="6429295" y="3613933"/>
            <a:ext cx="15055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lucose Solution</a:t>
            </a:r>
            <a:endParaRPr lang="en-US" sz="1200" dirty="0"/>
          </a:p>
        </p:txBody>
      </p:sp>
      <p:sp>
        <p:nvSpPr>
          <p:cNvPr id="37" name="Rectangle 36"/>
          <p:cNvSpPr/>
          <p:nvPr/>
        </p:nvSpPr>
        <p:spPr>
          <a:xfrm>
            <a:off x="5843276" y="4551128"/>
            <a:ext cx="191270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 50 ml to basal media.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9405970" y="574880"/>
            <a:ext cx="17482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ino Acid Solution</a:t>
            </a:r>
            <a:endParaRPr lang="en-US" sz="1200" dirty="0"/>
          </a:p>
        </p:txBody>
      </p:sp>
      <p:sp>
        <p:nvSpPr>
          <p:cNvPr id="39" name="Rectangle 38"/>
          <p:cNvSpPr/>
          <p:nvPr/>
        </p:nvSpPr>
        <p:spPr>
          <a:xfrm>
            <a:off x="8526761" y="4981459"/>
            <a:ext cx="3292852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solve in 837.5 ml </a:t>
            </a:r>
            <a:r>
              <a:rPr kumimoji="0" lang="en-US" altLang="en-US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iQ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ter. Add other solutions to this bottle. 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0" y="27490"/>
            <a:ext cx="12192000" cy="3838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2: </a:t>
            </a:r>
            <a:r>
              <a:rPr lang="en-US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actobacillus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fined Medium 4 (LDM4) Recipe</a:t>
            </a:r>
            <a:endParaRPr lang="en-US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8608461" y="5771018"/>
            <a:ext cx="3330497" cy="27735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/>
          <p:cNvSpPr/>
          <p:nvPr/>
        </p:nvSpPr>
        <p:spPr>
          <a:xfrm>
            <a:off x="9140089" y="5756502"/>
            <a:ext cx="2460930" cy="3046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semble and adjust pH to 6.5 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47305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Rectangle 30"/>
          <p:cNvSpPr/>
          <p:nvPr/>
        </p:nvSpPr>
        <p:spPr>
          <a:xfrm>
            <a:off x="7982900" y="2042157"/>
            <a:ext cx="3360809" cy="24544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3807247" y="3367458"/>
            <a:ext cx="3792777" cy="26351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3807248" y="4850105"/>
            <a:ext cx="3792776" cy="26351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3868457" y="746412"/>
            <a:ext cx="3731569" cy="26351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7979630" y="746412"/>
            <a:ext cx="3360809" cy="24544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174598" y="746412"/>
            <a:ext cx="3360809" cy="245444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74598" y="1097414"/>
          <a:ext cx="3360809" cy="4914993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36658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42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(g)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 Alan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Arginine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artic Acid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Cysteine hydrochloride monohydrat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48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Glutamic Acid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yc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Histid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Isoleuc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Leuc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Lysine monohydrochlorid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48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Methion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Phenylalan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Prol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Ser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Threon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Tryptophan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Tyros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Valin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tassium Phosphate Monobasic (KH</a:t>
                      </a:r>
                      <a:r>
                        <a:rPr lang="en-US" sz="1100" u="none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</a:t>
                      </a:r>
                      <a:r>
                        <a:rPr lang="en-US" sz="1100" u="none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 Phosphate Dibasic (Na</a:t>
                      </a:r>
                      <a:r>
                        <a:rPr lang="en-US" sz="1100" u="none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PO</a:t>
                      </a:r>
                      <a:r>
                        <a:rPr lang="en-US" sz="1100" u="none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 Chlorid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 Bicarbonate (NaHCO</a:t>
                      </a:r>
                      <a:r>
                        <a:rPr lang="en-US" sz="1100" u="none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130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cos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4496" marR="64496" marT="0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7982902" y="2368266"/>
          <a:ext cx="3360809" cy="1427607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08228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785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(g)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iamine Hydrochlorid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1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-Pantothenic acid </a:t>
                      </a:r>
                      <a:r>
                        <a:rPr lang="en-US" sz="1100" u="non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icalcium</a:t>
                      </a: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alt (4°C)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 01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cotinamid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 01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yridoxine Hydrochloride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 01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minobenzoic acid (4°C)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 005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tamin B12 (4°C)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 0005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7979629" y="1097414"/>
          <a:ext cx="3360809" cy="52920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04950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1130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(g)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ic Acid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5 g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OH</a:t>
                      </a: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 M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ml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3815410" y="5190762"/>
          <a:ext cx="3784614" cy="56197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6642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039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278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(g)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278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otin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25 g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3341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 % Ethanol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w drops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3818054" y="3723485"/>
          <a:ext cx="3781971" cy="529209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66062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134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(g)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boflavin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 g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etic Acid 0.02 M</a:t>
                      </a:r>
                      <a:endParaRPr lang="en-US" sz="1100" u="none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ml</a:t>
                      </a:r>
                      <a:endParaRPr lang="en-US" sz="1100" u="none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3868458" y="1097414"/>
          <a:ext cx="3731569" cy="1685925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7928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387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278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gredient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u="non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unt (g)</a:t>
                      </a:r>
                      <a:endParaRPr lang="en-US" sz="1100" u="non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278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monium Sulfate [(NH4)2SO4]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278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lcium Chloride </a:t>
                      </a: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hydrate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CaCl2-2H2O]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278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rrous Sulfate Heptahydrate [FeSO4-7H2O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278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nesium Chloride Hexahydrate [MgCl2-6H2O]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278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ganese Chloride </a:t>
                      </a:r>
                      <a:r>
                        <a:rPr lang="en-US" sz="11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trahydrate</a:t>
                      </a: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MnCl2-4H2O]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0" name="Rectangle 9"/>
          <p:cNvSpPr/>
          <p:nvPr/>
        </p:nvSpPr>
        <p:spPr>
          <a:xfrm>
            <a:off x="1284250" y="760635"/>
            <a:ext cx="12554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e Solution </a:t>
            </a:r>
            <a:endParaRPr lang="en-US" sz="1200" dirty="0"/>
          </a:p>
        </p:txBody>
      </p:sp>
      <p:sp>
        <p:nvSpPr>
          <p:cNvPr id="11" name="Rectangle 10"/>
          <p:cNvSpPr/>
          <p:nvPr/>
        </p:nvSpPr>
        <p:spPr>
          <a:xfrm>
            <a:off x="8581929" y="715594"/>
            <a:ext cx="29546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0x Folic Acid Solution	</a:t>
            </a:r>
            <a:endParaRPr lang="en-US" sz="1200" dirty="0"/>
          </a:p>
        </p:txBody>
      </p:sp>
      <p:sp>
        <p:nvSpPr>
          <p:cNvPr id="12" name="Rectangle 11"/>
          <p:cNvSpPr/>
          <p:nvPr/>
        </p:nvSpPr>
        <p:spPr>
          <a:xfrm>
            <a:off x="5209531" y="737841"/>
            <a:ext cx="20313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neral Solution	</a:t>
            </a:r>
            <a:endParaRPr lang="en-US" sz="1200" dirty="0"/>
          </a:p>
        </p:txBody>
      </p:sp>
      <p:sp>
        <p:nvSpPr>
          <p:cNvPr id="13" name="Rectangle 12"/>
          <p:cNvSpPr/>
          <p:nvPr/>
        </p:nvSpPr>
        <p:spPr>
          <a:xfrm>
            <a:off x="4771743" y="4845128"/>
            <a:ext cx="20313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0x Biotin Solution	</a:t>
            </a:r>
            <a:endParaRPr lang="en-US" sz="1200" dirty="0"/>
          </a:p>
        </p:txBody>
      </p:sp>
      <p:sp>
        <p:nvSpPr>
          <p:cNvPr id="14" name="Rectangle 13"/>
          <p:cNvSpPr/>
          <p:nvPr/>
        </p:nvSpPr>
        <p:spPr>
          <a:xfrm>
            <a:off x="8962607" y="2016634"/>
            <a:ext cx="17416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x Vitamin Solution </a:t>
            </a:r>
            <a:endParaRPr lang="en-US" sz="1200" dirty="0"/>
          </a:p>
        </p:txBody>
      </p:sp>
      <p:sp>
        <p:nvSpPr>
          <p:cNvPr id="15" name="Rectangle 14"/>
          <p:cNvSpPr/>
          <p:nvPr/>
        </p:nvSpPr>
        <p:spPr>
          <a:xfrm>
            <a:off x="4778025" y="3353971"/>
            <a:ext cx="194155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0x Riboflavin Solution</a:t>
            </a:r>
            <a:endParaRPr lang="en-US" sz="1200" dirty="0"/>
          </a:p>
        </p:txBody>
      </p:sp>
      <p:sp>
        <p:nvSpPr>
          <p:cNvPr id="16" name="Rectangle 15"/>
          <p:cNvSpPr/>
          <p:nvPr/>
        </p:nvSpPr>
        <p:spPr>
          <a:xfrm>
            <a:off x="121234" y="6362416"/>
            <a:ext cx="230543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solve in 960 ml </a:t>
            </a:r>
            <a:r>
              <a:rPr kumimoji="0" lang="en-US" altLang="en-US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iQ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ter. </a:t>
            </a:r>
            <a:endParaRPr lang="en-US" sz="1100" b="1" dirty="0"/>
          </a:p>
        </p:txBody>
      </p:sp>
      <p:sp>
        <p:nvSpPr>
          <p:cNvPr id="17" name="Rectangle 16"/>
          <p:cNvSpPr/>
          <p:nvPr/>
        </p:nvSpPr>
        <p:spPr>
          <a:xfrm>
            <a:off x="3807248" y="2824194"/>
            <a:ext cx="379277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solve in 10 ml </a:t>
            </a:r>
            <a:r>
              <a:rPr kumimoji="0" lang="en-US" altLang="en-US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Q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ter and</a:t>
            </a:r>
            <a:r>
              <a:rPr kumimoji="0" lang="en-US" altLang="en-US" sz="1100" b="1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dd to 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al medium 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3744786" y="4321897"/>
            <a:ext cx="3496070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kumimoji="0" lang="en-US" altLang="en-US" sz="1100" b="1" i="0" u="none" strike="noStrike" cap="none" normalizeH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d 2.5ml to 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al medium 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3744786" y="5820636"/>
            <a:ext cx="3855238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solve in 100 ml </a:t>
            </a:r>
            <a:r>
              <a:rPr kumimoji="0" lang="en-US" altLang="en-US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iQ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ter and add 1 ml to basal medium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7918531" y="3910554"/>
            <a:ext cx="3386239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issolve in 100 ml of </a:t>
            </a:r>
            <a:r>
              <a:rPr kumimoji="0" lang="en-US" altLang="en-US" sz="1100" b="1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lliQ</a:t>
            </a: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ater and add 10.0 ml to basal medium</a:t>
            </a:r>
            <a:endParaRPr lang="en-US" sz="1100" b="1" dirty="0"/>
          </a:p>
        </p:txBody>
      </p:sp>
      <p:sp>
        <p:nvSpPr>
          <p:cNvPr id="21" name="Rectangle 20"/>
          <p:cNvSpPr/>
          <p:nvPr/>
        </p:nvSpPr>
        <p:spPr>
          <a:xfrm>
            <a:off x="7979628" y="1690288"/>
            <a:ext cx="310694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1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dd 100 µl to the autoclaved basal medium.</a:t>
            </a:r>
            <a:endParaRPr kumimoji="0" lang="en-US" altLang="en-US" sz="1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/>
          <p:cNvSpPr/>
          <p:nvPr/>
        </p:nvSpPr>
        <p:spPr>
          <a:xfrm>
            <a:off x="1600" y="19944"/>
            <a:ext cx="12192000" cy="410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</a:t>
            </a:r>
            <a:r>
              <a:rPr lang="en-US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3: </a:t>
            </a:r>
            <a:r>
              <a:rPr lang="en-US" alt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emically Defined Minimal Media (CDMM) 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cipe</a:t>
            </a:r>
            <a:endParaRPr lang="en-US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7979628" y="4542029"/>
            <a:ext cx="3360810" cy="277354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8511256" y="4527513"/>
            <a:ext cx="2417650" cy="3046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semble and adjust pH to 7.4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09577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1381" y="1025933"/>
            <a:ext cx="8389238" cy="4806134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180304" y="0"/>
            <a:ext cx="8023538" cy="5669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4: Bacterial Folate Synthesis </a:t>
            </a:r>
            <a:r>
              <a:rPr lang="en-US" b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 Primers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589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717</Words>
  <Application>Microsoft Office PowerPoint</Application>
  <PresentationFormat>Widescreen</PresentationFormat>
  <Paragraphs>25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Baylor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ngevik, Melinda</dc:creator>
  <cp:lastModifiedBy>Frontiers</cp:lastModifiedBy>
  <cp:revision>2</cp:revision>
  <dcterms:created xsi:type="dcterms:W3CDTF">2019-08-31T02:23:45Z</dcterms:created>
  <dcterms:modified xsi:type="dcterms:W3CDTF">2019-09-30T09:42:46Z</dcterms:modified>
</cp:coreProperties>
</file>